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5" d="100"/>
          <a:sy n="75" d="100"/>
        </p:scale>
        <p:origin x="1692" y="-18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2443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225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89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59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7017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62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257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4578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2767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2622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257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6C3F9-D99C-44A4-BA00-890A16F3208C}" type="datetimeFigureOut">
              <a:rPr lang="zh-CN" altLang="en-US" smtClean="0"/>
              <a:t>2021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84282-A8B5-41FF-97B3-F824F9AE7A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53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DC727374-4E5B-4F21-BFBE-6C33442433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1013634"/>
          </a:xfrm>
        </p:spPr>
        <p:txBody>
          <a:bodyPr>
            <a:normAutofit/>
          </a:bodyPr>
          <a:lstStyle/>
          <a:p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Optimization of tissue culturing and genetic transformation protocol for </a:t>
            </a:r>
            <a:r>
              <a:rPr lang="en-US" altLang="zh-CN" sz="1800" b="1" i="1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asuarina </a:t>
            </a:r>
            <a:r>
              <a:rPr lang="en-US" altLang="zh-CN" sz="1800" b="1" i="1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quisetifolia</a:t>
            </a:r>
            <a:endParaRPr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114094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0FF3745-CA76-42CA-B2E6-CB68D1FA8686}"/>
              </a:ext>
            </a:extLst>
          </p:cNvPr>
          <p:cNvSpPr txBox="1"/>
          <p:nvPr/>
        </p:nvSpPr>
        <p:spPr>
          <a:xfrm>
            <a:off x="427216" y="1557084"/>
            <a:ext cx="6003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Table. S1 Basal media with 38 different combinations of plant growth regulator for </a:t>
            </a:r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asuarina </a:t>
            </a:r>
            <a:r>
              <a:rPr lang="en-US" altLang="zh-CN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quisetifolia</a:t>
            </a:r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egeneratio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E929F4E8-FA81-445C-A103-A36F703D17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599" y="2053347"/>
            <a:ext cx="6616800" cy="50373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9693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6F892043-69DC-417E-9B6A-0C47331F66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1200" y="1092820"/>
            <a:ext cx="4575600" cy="604393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9CB200D-46D1-4340-A7DF-CB0AF66DBE94}"/>
              </a:ext>
            </a:extLst>
          </p:cNvPr>
          <p:cNvSpPr txBox="1"/>
          <p:nvPr/>
        </p:nvSpPr>
        <p:spPr>
          <a:xfrm>
            <a:off x="1060760" y="7305697"/>
            <a:ext cx="48413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. S1 Induced callus on basal media with 38 different combinations of plant growth regulator.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464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1DADF79-14E4-4F61-80E0-CB022C853F9F}"/>
              </a:ext>
            </a:extLst>
          </p:cNvPr>
          <p:cNvSpPr txBox="1"/>
          <p:nvPr/>
        </p:nvSpPr>
        <p:spPr>
          <a:xfrm>
            <a:off x="1061253" y="2051709"/>
            <a:ext cx="44246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Table. S2 Optimal concentration of supplementary elements for transformation system.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40B90F2-1FD4-4336-B6CB-FBF4C89AA0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157" y="2539947"/>
            <a:ext cx="4006800" cy="2390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585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8E053253-3B59-4803-8273-38D9C03154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600" y="304801"/>
            <a:ext cx="3610800" cy="7793971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C68CE6C-EC21-4CF5-867F-64B0084BAFCA}"/>
              </a:ext>
            </a:extLst>
          </p:cNvPr>
          <p:cNvSpPr txBox="1"/>
          <p:nvPr/>
        </p:nvSpPr>
        <p:spPr>
          <a:xfrm>
            <a:off x="1321469" y="8254424"/>
            <a:ext cx="468487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. S2  </a:t>
            </a:r>
            <a:r>
              <a:rPr lang="en-US" altLang="zh-CN" sz="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US expression in transgenic </a:t>
            </a:r>
            <a:r>
              <a:rPr lang="en-US" altLang="zh-CN" sz="800" b="1" i="1" kern="0" dirty="0">
                <a:solidFill>
                  <a:srgbClr val="000000"/>
                </a:solidFill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C. </a:t>
            </a:r>
            <a:r>
              <a:rPr lang="en-US" altLang="zh-CN" sz="800" b="1" i="1" kern="0" dirty="0" err="1">
                <a:solidFill>
                  <a:srgbClr val="000000"/>
                </a:solidFill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equisetifolia</a:t>
            </a:r>
            <a:r>
              <a:rPr lang="en-US" altLang="zh-CN" sz="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lants and control.</a:t>
            </a:r>
          </a:p>
          <a:p>
            <a:r>
              <a:rPr lang="en-US" altLang="zh-CN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. GUS expression in transgenic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allus and control</a:t>
            </a:r>
            <a:r>
              <a:rPr lang="en-US" altLang="zh-CN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B. GUS expression in transgenic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dventitious</a:t>
            </a:r>
            <a:r>
              <a:rPr lang="en-US" altLang="zh-CN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ud and control. C.</a:t>
            </a:r>
            <a:r>
              <a:rPr lang="en-US" altLang="zh-CN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GUS expression in transgenic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oot and control. D. </a:t>
            </a:r>
            <a:r>
              <a:rPr lang="en-US" altLang="zh-CN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US expression in transgenic seedling and control.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3210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12</Words>
  <Application>Microsoft Office PowerPoint</Application>
  <PresentationFormat>信纸(8.5x11 英寸)</PresentationFormat>
  <Paragraphs>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主题​​</vt:lpstr>
      <vt:lpstr>Optimization of tissue culturing and genetic transformation protocol for Casuarina equisetifolia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ptimization of tissue culturing and genetic transformation protocol for Casuarina equisetifolia</dc:title>
  <dc:creator> </dc:creator>
  <cp:lastModifiedBy> </cp:lastModifiedBy>
  <cp:revision>1</cp:revision>
  <dcterms:created xsi:type="dcterms:W3CDTF">2021-08-24T10:08:13Z</dcterms:created>
  <dcterms:modified xsi:type="dcterms:W3CDTF">2021-08-24T10:19:12Z</dcterms:modified>
</cp:coreProperties>
</file>